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00E4B-7A00-4DA3-A4D6-58CE58718C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CCAD9-E289-471D-92A4-5C7BDABBA9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B2958-A906-4FD1-B736-80FC8410E2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57D53-B24B-4FFC-AD2E-01AC484FCC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82DF8-E389-42BD-9EDE-75E7E19EAA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689484-33D0-4E84-B0E6-17EA79A3FE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92FB9-8019-45DE-9B64-BB273E0E79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6694CE-70AC-43DC-9CF5-446DCCCB89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3D58D-CAD1-4C92-8F13-D978D4FF91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B7AC2-8776-47C9-A068-102CFD1407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D02B4-A039-4D78-BB07-D51B16D1F1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82546-F0B5-4939-B1EB-94BE7783A2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D21A19-55A1-4348-9F1C-E120B85A763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0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66600" y="798480"/>
            <a:ext cx="8977320" cy="3720960"/>
          </a:xfrm>
          <a:prstGeom prst="rect">
            <a:avLst/>
          </a:prstGeom>
          <a:ln w="0">
            <a:noFill/>
          </a:ln>
        </p:spPr>
      </p:pic>
      <p:sp>
        <p:nvSpPr>
          <p:cNvPr id="42" name="PlaceHolder 1"/>
          <p:cNvSpPr>
            <a:spLocks noGrp="1"/>
          </p:cNvSpPr>
          <p:nvPr>
            <p:ph/>
          </p:nvPr>
        </p:nvSpPr>
        <p:spPr>
          <a:xfrm>
            <a:off x="304920" y="4624200"/>
            <a:ext cx="8229600" cy="194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 algn="just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S8. Differential expression of genes in the canonical integrin signaling pathway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Genes are represented as nodes, biological relationships between two nodes as lines; nodes are displayed using various shapes that represent the functional class of the gene product. The intensity of the node color indicates the degree of up- (red) or down- (green) regulation in CRI-G1-RS cells relative to CRI-G1-RR cells; gray node color indicates genes showing no differential expression between RR and RS cells, while white node color marks genes that were not present on the array. Protein complexes/gene groups are indicated by nodes with double outlines; color shading within such a node indicates that genes within the complex/gene group showed different expression changes. The analysis was performed on 3917 probes with FDR-adjusted p-value ≤ 0.001, regardless of the fold change. When multiple probes were present for a single gene, the probe with the smallest p-value was us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19T19:00:45Z</dcterms:created>
  <dc:creator>Marta Margeta</dc:creator>
  <dc:description/>
  <dc:language>en-US</dc:language>
  <cp:lastModifiedBy>Marta Margeta</cp:lastModifiedBy>
  <dcterms:modified xsi:type="dcterms:W3CDTF">2010-06-28T21:53:04Z</dcterms:modified>
  <cp:revision>4</cp:revision>
  <dc:subject/>
  <dc:title>Slide 1</dc:title>
</cp:coreProperties>
</file>